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960059"/>
    <a:srgbClr val="860050"/>
    <a:srgbClr val="0092F7"/>
    <a:srgbClr val="AA0065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96E9F76-5DAE-4C1E-87BA-477789C14088}" v="1" dt="2025-01-10T15:46:25.3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67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-18046"/>
            <a:ext cx="1039632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00000"/>
              </a:lnSpc>
            </a:pPr>
            <a:r>
              <a:rPr lang="en-US" sz="3200" kern="100" dirty="0">
                <a:solidFill>
                  <a:schemeClr val="bg1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hallenges in blood pressure measurement in children with obesity: focus on the cuff</a:t>
            </a:r>
            <a:endParaRPr lang="en-GR" sz="3200" kern="100" dirty="0">
              <a:solidFill>
                <a:schemeClr val="bg1"/>
              </a:solidFill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457201" y="1186895"/>
            <a:ext cx="6450496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Key points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</a:p>
          <a:p>
            <a:pPr algn="just">
              <a:spcAft>
                <a:spcPts val="1200"/>
              </a:spcAft>
            </a:pP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.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Proper diagnosis of hypertension in the case of pediatric obesity is of major importance. Careful cuff selection improves measurement accuracy and reduces misdiagnosis.</a:t>
            </a:r>
            <a:endParaRPr lang="en-GB" sz="1600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1200"/>
              </a:spcAft>
            </a:pP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.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According to adult studies, </a:t>
            </a:r>
            <a:r>
              <a:rPr lang="en-GR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ylindrical cuffs may lead to overestimation of blood pressure (BP) while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conical cuffs are more accurate, as they better accommodate the large arm's conical shape.</a:t>
            </a:r>
            <a:endParaRPr lang="en-GB" sz="1600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1200"/>
              </a:spcAft>
            </a:pP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.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Guidelines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recommend cone-shaped cuffs for accurate BP measurement in adult individuals with large arm circumference (AC &gt; 42 cm).</a:t>
            </a:r>
            <a:endParaRPr lang="en-GB" sz="1600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1200"/>
              </a:spcAft>
            </a:pP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.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The only study conducted in pediatric patients found similar BP readings using cylindrical and conical cuffs in children with obesity.</a:t>
            </a:r>
            <a:endParaRPr lang="en-GB" sz="1600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1200"/>
              </a:spcAft>
            </a:pP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5. </a:t>
            </a:r>
            <a:r>
              <a:rPr lang="en-GB" sz="1600" dirty="0">
                <a:latin typeface="Calibri" panose="020F0502020204030204" pitchFamily="34" charset="0"/>
                <a:cs typeface="Calibri" panose="020F0502020204030204" pitchFamily="34" charset="0"/>
              </a:rPr>
              <a:t>Current BP device validation protocols lack criteria for arm size, raising concerns about accuracy in children with obesity. Including conical cuffs in validation studies could improve measurements for this population.</a:t>
            </a:r>
            <a:endParaRPr lang="en-GB" sz="1600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92888" y="5673648"/>
            <a:ext cx="3776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Evripidou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51691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700" dirty="0">
                <a:solidFill>
                  <a:schemeClr val="bg1"/>
                </a:solidFill>
              </a:rPr>
              <a:t>Accurate BP measurement in children with obesity is crucial. It </a:t>
            </a:r>
            <a:r>
              <a:rPr lang="en-GR" sz="1700" dirty="0">
                <a:solidFill>
                  <a:schemeClr val="bg1"/>
                </a:solidFill>
              </a:rPr>
              <a:t>requires proper cuff selection based on arm size and shape, with conical cuffs potentially offering a better alternative to cylindrical ones, </a:t>
            </a:r>
            <a:r>
              <a:rPr lang="en-GB" sz="1700" dirty="0">
                <a:solidFill>
                  <a:schemeClr val="bg1"/>
                </a:solidFill>
              </a:rPr>
              <a:t>but more validation studies are needed</a:t>
            </a:r>
            <a:r>
              <a:rPr lang="en-GR" sz="1700" dirty="0">
                <a:solidFill>
                  <a:schemeClr val="bg1"/>
                </a:solidFill>
              </a:rPr>
              <a:t>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45A6201-E8CC-B35D-A4EB-CD0A7626D0E6}"/>
              </a:ext>
            </a:extLst>
          </p:cNvPr>
          <p:cNvSpPr txBox="1"/>
          <p:nvPr/>
        </p:nvSpPr>
        <p:spPr>
          <a:xfrm>
            <a:off x="3037462" y="3210287"/>
            <a:ext cx="61138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R" dirty="0"/>
          </a:p>
        </p:txBody>
      </p:sp>
      <p:pic>
        <p:nvPicPr>
          <p:cNvPr id="16" name="Picture 15" descr="A diagram of a cylinder&#10;&#10;Description automatically generated">
            <a:extLst>
              <a:ext uri="{FF2B5EF4-FFF2-40B4-BE49-F238E27FC236}">
                <a16:creationId xmlns:a16="http://schemas.microsoft.com/office/drawing/2014/main" id="{01E42958-D7CC-C64E-8B3D-BA2589466B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58" t="6667" r="11867"/>
          <a:stretch/>
        </p:blipFill>
        <p:spPr>
          <a:xfrm>
            <a:off x="9781285" y="1984406"/>
            <a:ext cx="2159542" cy="272410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F7F610E-E4D1-2219-09E1-AAFCF04B73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7928" y="1361430"/>
            <a:ext cx="3212517" cy="4067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73</TotalTime>
  <Words>21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5</cp:revision>
  <dcterms:created xsi:type="dcterms:W3CDTF">2019-06-13T12:30:18Z</dcterms:created>
  <dcterms:modified xsi:type="dcterms:W3CDTF">2025-01-10T15:50:57Z</dcterms:modified>
</cp:coreProperties>
</file>